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6303" autoAdjust="0"/>
  </p:normalViewPr>
  <p:slideViewPr>
    <p:cSldViewPr snapToGrid="0">
      <p:cViewPr varScale="1">
        <p:scale>
          <a:sx n="77" d="100"/>
          <a:sy n="77" d="100"/>
        </p:scale>
        <p:origin x="91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8221E1-0BA6-42DD-9D4F-34405E02880F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64962B-7B0D-4A71-93CA-C1D366D31C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6614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 smtClean="0"/>
              <a:t>Additional File </a:t>
            </a:r>
            <a:r>
              <a:rPr lang="en-US" b="1" dirty="0" smtClean="0"/>
              <a:t>4: </a:t>
            </a:r>
            <a:r>
              <a:rPr lang="en-US" b="1" dirty="0" smtClean="0"/>
              <a:t>Table S3.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is-regulatory analysis of genes differentially expressed (FDR ≤0.1) during aging by </a:t>
            </a:r>
            <a:r>
              <a:rPr lang="en-US" b="1" dirty="0" smtClean="0"/>
              <a:t>oPOSSUM-3.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hows transcription factor binding sites found to be enriched in +/- 10kb regions flanking transcription start site of target genes (excluding coding regions). See Methods for explanation of Z-score and Fisher p-value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AD4B55-A05D-4820-9737-5DBBF42226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99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213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755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50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03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055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857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066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158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016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654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906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8DBB8-C2CF-4ADB-8CE3-9330DB49F160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38542-B502-44C7-B14A-CD2B998E9D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97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2057400" y="1350963"/>
          <a:ext cx="7184316" cy="415687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408339"/>
                <a:gridCol w="484539"/>
                <a:gridCol w="868133"/>
                <a:gridCol w="537536"/>
                <a:gridCol w="484539"/>
                <a:gridCol w="484539"/>
                <a:gridCol w="286436"/>
                <a:gridCol w="682642"/>
                <a:gridCol w="484539"/>
                <a:gridCol w="484539"/>
                <a:gridCol w="405680"/>
                <a:gridCol w="967181"/>
                <a:gridCol w="605674"/>
              </a:tblGrid>
              <a:tr h="27415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ell 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rec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en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# of Target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Z-scor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F </a:t>
                      </a:r>
                      <a:r>
                        <a:rPr lang="en-US" sz="900" u="none" strike="noStrike" dirty="0" smtClean="0">
                          <a:effectLst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ell 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irec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en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# of Target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Z-scor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F </a:t>
                      </a:r>
                      <a:r>
                        <a:rPr lang="en-US" sz="900" u="none" strike="noStrike" dirty="0" smtClean="0">
                          <a:effectLst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F-</a:t>
                      </a:r>
                      <a:r>
                        <a:rPr lang="en-US" sz="900" u="none" strike="noStrike" dirty="0" err="1">
                          <a:effectLst/>
                        </a:rPr>
                        <a:t>kappa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2.8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7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R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.8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6033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REL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2.4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46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FK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.4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3351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27415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A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2.0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8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F-kappa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.4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11803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FIL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9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100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.3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801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RE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7.1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8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L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0.3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328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smtClean="0">
                          <a:effectLst/>
                        </a:rPr>
                        <a:t>IRF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54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94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S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7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663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274152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PARG::RXR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1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1073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U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NF1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2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193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15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Cell Typ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Direc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Gen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effectLst/>
                        </a:rPr>
                        <a:t># of Target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Z-scor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F </a:t>
                      </a:r>
                      <a:r>
                        <a:rPr lang="en-US" sz="900" b="1" u="none" strike="noStrike" dirty="0" smtClean="0">
                          <a:effectLst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Cell 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Direc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Gen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effectLst/>
                        </a:rPr>
                        <a:t># of Target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Z-scor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F </a:t>
                      </a:r>
                      <a:r>
                        <a:rPr lang="en-US" sz="900" b="1" u="none" strike="noStrike" dirty="0" smtClean="0">
                          <a:effectLst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A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3.0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75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dx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6.6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0.010889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R1H2::RXR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86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69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B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.5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7.6208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L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8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02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hx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1.7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3715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XR::RAR_D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0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3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rrx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0.9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4255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pz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17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F2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7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1779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P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8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78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E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1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.3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2824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aï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y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5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NF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9.35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1370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9.0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807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OXI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8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319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OX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8.4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3548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/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R>
                      <a:noFill/>
                    </a:ln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em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ow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FIL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7.7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0.0001064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B>
                      <a:noFill/>
                    </a:lnB>
                  </a:tcPr>
                </a:tc>
              </a:tr>
              <a:tr h="15146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Memor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Dow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ELF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>
                          <a:effectLst/>
                        </a:rPr>
                        <a:t>0.007014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73" marR="7573" marT="7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8200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5</Words>
  <Application>Microsoft Office PowerPoint</Application>
  <PresentationFormat>Widescreen</PresentationFormat>
  <Paragraphs>2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 T</dc:creator>
  <cp:lastModifiedBy>J T</cp:lastModifiedBy>
  <cp:revision>2</cp:revision>
  <dcterms:created xsi:type="dcterms:W3CDTF">2016-12-29T21:12:27Z</dcterms:created>
  <dcterms:modified xsi:type="dcterms:W3CDTF">2017-04-03T01:44:01Z</dcterms:modified>
</cp:coreProperties>
</file>